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D5E953-DB79-4EBC-934A-608ADE1105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F0A11-522C-42D0-986F-F72D2FA724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CD8C0-5521-433C-AF6D-311B89F3AE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E4F48-0405-4EB6-ACF4-B175CBAAC1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6AAE59-1F3D-4ECB-8BE3-35884EEF130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4593E9-A838-4E43-BC21-67351A4E2A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A9DD12-86C5-4652-9060-B56F0AD94FD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1C40C-B676-40B1-BEA6-42B4DBE6FE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41579-01B6-4DE9-8C73-9AF091BE5D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A83D4-288D-4FF3-8131-2419217528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4D271-7DC0-4F60-A2AA-F0CADFCFD8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96B449-7E30-47ED-A0D9-ED9AF7AB44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6FC64B-998B-4C69-ABF0-DEC848B6170F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BE54E0-D21E-472C-9198-878C036DBFA0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1"/>
          <p:cNvSpPr/>
          <p:nvPr/>
        </p:nvSpPr>
        <p:spPr>
          <a:xfrm>
            <a:off x="1495440" y="239544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3"/>
          <p:cNvSpPr/>
          <p:nvPr/>
        </p:nvSpPr>
        <p:spPr>
          <a:xfrm>
            <a:off x="1495440" y="498636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4"/>
          <p:cNvSpPr/>
          <p:nvPr/>
        </p:nvSpPr>
        <p:spPr>
          <a:xfrm>
            <a:off x="1495440" y="199872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65"/>
          <p:cNvSpPr/>
          <p:nvPr/>
        </p:nvSpPr>
        <p:spPr>
          <a:xfrm>
            <a:off x="2214720" y="1558800"/>
            <a:ext cx="43290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12  </a:t>
            </a: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 RT-PCR cycling condition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57"/>
          <p:cNvSpPr/>
          <p:nvPr/>
        </p:nvSpPr>
        <p:spPr>
          <a:xfrm>
            <a:off x="1600200" y="460836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Hold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0"/>
          <p:cNvSpPr/>
          <p:nvPr/>
        </p:nvSpPr>
        <p:spPr>
          <a:xfrm>
            <a:off x="3776760" y="243216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95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61"/>
          <p:cNvSpPr/>
          <p:nvPr/>
        </p:nvSpPr>
        <p:spPr>
          <a:xfrm>
            <a:off x="1600200" y="2430360"/>
            <a:ext cx="1754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Initial denatu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62"/>
          <p:cNvSpPr/>
          <p:nvPr/>
        </p:nvSpPr>
        <p:spPr>
          <a:xfrm>
            <a:off x="4722840" y="2443320"/>
            <a:ext cx="1204920" cy="30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04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2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69"/>
          <p:cNvSpPr/>
          <p:nvPr/>
        </p:nvSpPr>
        <p:spPr>
          <a:xfrm>
            <a:off x="1600200" y="3301920"/>
            <a:ext cx="1217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Annealing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73"/>
          <p:cNvSpPr/>
          <p:nvPr/>
        </p:nvSpPr>
        <p:spPr>
          <a:xfrm>
            <a:off x="4722840" y="3271680"/>
            <a:ext cx="120492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30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4"/>
          <p:cNvSpPr/>
          <p:nvPr/>
        </p:nvSpPr>
        <p:spPr>
          <a:xfrm>
            <a:off x="3776760" y="288432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95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8"/>
          <p:cNvSpPr/>
          <p:nvPr/>
        </p:nvSpPr>
        <p:spPr>
          <a:xfrm>
            <a:off x="3776760" y="378936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72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9"/>
          <p:cNvSpPr/>
          <p:nvPr/>
        </p:nvSpPr>
        <p:spPr>
          <a:xfrm>
            <a:off x="3776760" y="333684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60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11"/>
          <p:cNvSpPr/>
          <p:nvPr/>
        </p:nvSpPr>
        <p:spPr>
          <a:xfrm>
            <a:off x="3789360" y="4657680"/>
            <a:ext cx="71928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4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12"/>
          <p:cNvSpPr/>
          <p:nvPr/>
        </p:nvSpPr>
        <p:spPr>
          <a:xfrm>
            <a:off x="3776760" y="424188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72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15"/>
          <p:cNvSpPr/>
          <p:nvPr/>
        </p:nvSpPr>
        <p:spPr>
          <a:xfrm>
            <a:off x="4722840" y="3733920"/>
            <a:ext cx="120492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1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19"/>
          <p:cNvSpPr/>
          <p:nvPr/>
        </p:nvSpPr>
        <p:spPr>
          <a:xfrm>
            <a:off x="4722840" y="2858040"/>
            <a:ext cx="1204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20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26"/>
          <p:cNvSpPr/>
          <p:nvPr/>
        </p:nvSpPr>
        <p:spPr>
          <a:xfrm>
            <a:off x="4722840" y="4199400"/>
            <a:ext cx="1204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5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29"/>
          <p:cNvSpPr/>
          <p:nvPr/>
        </p:nvSpPr>
        <p:spPr>
          <a:xfrm>
            <a:off x="4722840" y="4618800"/>
            <a:ext cx="1204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300" spc="-1" strike="noStrike">
                <a:solidFill>
                  <a:srgbClr val="000000"/>
                </a:solidFill>
                <a:latin typeface="Calibri"/>
              </a:rPr>
              <a:t>∞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31"/>
          <p:cNvSpPr/>
          <p:nvPr/>
        </p:nvSpPr>
        <p:spPr>
          <a:xfrm>
            <a:off x="5364000" y="423864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32"/>
          <p:cNvSpPr/>
          <p:nvPr/>
        </p:nvSpPr>
        <p:spPr>
          <a:xfrm>
            <a:off x="5307120" y="4656240"/>
            <a:ext cx="244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33"/>
          <p:cNvSpPr/>
          <p:nvPr/>
        </p:nvSpPr>
        <p:spPr>
          <a:xfrm>
            <a:off x="5365800" y="241920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34"/>
          <p:cNvSpPr/>
          <p:nvPr/>
        </p:nvSpPr>
        <p:spPr>
          <a:xfrm>
            <a:off x="1865160" y="2058840"/>
            <a:ext cx="824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tep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本框 37"/>
          <p:cNvSpPr/>
          <p:nvPr/>
        </p:nvSpPr>
        <p:spPr>
          <a:xfrm>
            <a:off x="5035680" y="2085840"/>
            <a:ext cx="12016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Tim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本框 38"/>
          <p:cNvSpPr/>
          <p:nvPr/>
        </p:nvSpPr>
        <p:spPr>
          <a:xfrm>
            <a:off x="6197760" y="2066760"/>
            <a:ext cx="645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Cycl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本框 10"/>
          <p:cNvSpPr/>
          <p:nvPr/>
        </p:nvSpPr>
        <p:spPr>
          <a:xfrm>
            <a:off x="3483000" y="2054160"/>
            <a:ext cx="1136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Temperatur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本框 5"/>
          <p:cNvSpPr/>
          <p:nvPr/>
        </p:nvSpPr>
        <p:spPr>
          <a:xfrm>
            <a:off x="1600200" y="2867040"/>
            <a:ext cx="1217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Denatu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6"/>
          <p:cNvSpPr/>
          <p:nvPr/>
        </p:nvSpPr>
        <p:spPr>
          <a:xfrm>
            <a:off x="1600200" y="3736800"/>
            <a:ext cx="987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Extens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本框 7"/>
          <p:cNvSpPr/>
          <p:nvPr/>
        </p:nvSpPr>
        <p:spPr>
          <a:xfrm>
            <a:off x="1600200" y="4172040"/>
            <a:ext cx="1343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Final extens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本框 20"/>
          <p:cNvSpPr/>
          <p:nvPr/>
        </p:nvSpPr>
        <p:spPr>
          <a:xfrm>
            <a:off x="5346720" y="331308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30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右大括号 40"/>
          <p:cNvSpPr/>
          <p:nvPr/>
        </p:nvSpPr>
        <p:spPr>
          <a:xfrm>
            <a:off x="5754600" y="2978280"/>
            <a:ext cx="324000" cy="1008000"/>
          </a:xfrm>
          <a:custGeom>
            <a:avLst/>
            <a:gdLst>
              <a:gd name="textAreaLeft" fmla="*/ 0 w 324000"/>
              <a:gd name="textAreaRight" fmla="*/ 117000 w 324000"/>
              <a:gd name="textAreaTop" fmla="*/ 8280 h 1008000"/>
              <a:gd name="textAreaBottom" fmla="*/ 999720 h 10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89"/>
                  <a:pt x="10800" y="578"/>
                </a:cubicBezTo>
                <a:lnTo>
                  <a:pt x="10800" y="10222"/>
                </a:lnTo>
                <a:cubicBezTo>
                  <a:pt x="10800" y="10511"/>
                  <a:pt x="16200" y="10800"/>
                  <a:pt x="21600" y="10800"/>
                </a:cubicBezTo>
                <a:cubicBezTo>
                  <a:pt x="16200" y="10800"/>
                  <a:pt x="10800" y="11089"/>
                  <a:pt x="10800" y="11378"/>
                </a:cubicBezTo>
                <a:lnTo>
                  <a:pt x="10800" y="21022"/>
                </a:lnTo>
                <a:cubicBezTo>
                  <a:pt x="10800" y="21311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7:45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